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5543550" cy="325755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68" autoAdjust="0"/>
    <p:restoredTop sz="94660"/>
  </p:normalViewPr>
  <p:slideViewPr>
    <p:cSldViewPr snapToGrid="0">
      <p:cViewPr varScale="1">
        <p:scale>
          <a:sx n="148" d="100"/>
          <a:sy n="148" d="100"/>
        </p:scale>
        <p:origin x="58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92944" y="533122"/>
            <a:ext cx="4157663" cy="1134110"/>
          </a:xfrm>
        </p:spPr>
        <p:txBody>
          <a:bodyPr anchor="b"/>
          <a:lstStyle>
            <a:lvl1pPr algn="ctr">
              <a:defRPr sz="2728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92944" y="1710968"/>
            <a:ext cx="4157663" cy="786487"/>
          </a:xfrm>
        </p:spPr>
        <p:txBody>
          <a:bodyPr/>
          <a:lstStyle>
            <a:lvl1pPr marL="0" indent="0" algn="ctr">
              <a:buNone/>
              <a:defRPr sz="1091"/>
            </a:lvl1pPr>
            <a:lvl2pPr marL="207889" indent="0" algn="ctr">
              <a:buNone/>
              <a:defRPr sz="909"/>
            </a:lvl2pPr>
            <a:lvl3pPr marL="415778" indent="0" algn="ctr">
              <a:buNone/>
              <a:defRPr sz="818"/>
            </a:lvl3pPr>
            <a:lvl4pPr marL="623667" indent="0" algn="ctr">
              <a:buNone/>
              <a:defRPr sz="728"/>
            </a:lvl4pPr>
            <a:lvl5pPr marL="831555" indent="0" algn="ctr">
              <a:buNone/>
              <a:defRPr sz="728"/>
            </a:lvl5pPr>
            <a:lvl6pPr marL="1039444" indent="0" algn="ctr">
              <a:buNone/>
              <a:defRPr sz="728"/>
            </a:lvl6pPr>
            <a:lvl7pPr marL="1247333" indent="0" algn="ctr">
              <a:buNone/>
              <a:defRPr sz="728"/>
            </a:lvl7pPr>
            <a:lvl8pPr marL="1455222" indent="0" algn="ctr">
              <a:buNone/>
              <a:defRPr sz="728"/>
            </a:lvl8pPr>
            <a:lvl9pPr marL="1663111" indent="0" algn="ctr">
              <a:buNone/>
              <a:defRPr sz="728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581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64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967103" y="173434"/>
            <a:ext cx="1195328" cy="2760623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1119" y="173434"/>
            <a:ext cx="3516690" cy="2760623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26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921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232" y="812126"/>
            <a:ext cx="4781312" cy="1355050"/>
          </a:xfrm>
        </p:spPr>
        <p:txBody>
          <a:bodyPr anchor="b"/>
          <a:lstStyle>
            <a:lvl1pPr>
              <a:defRPr sz="2728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232" y="2179995"/>
            <a:ext cx="4781312" cy="712589"/>
          </a:xfrm>
        </p:spPr>
        <p:txBody>
          <a:bodyPr/>
          <a:lstStyle>
            <a:lvl1pPr marL="0" indent="0">
              <a:buNone/>
              <a:defRPr sz="1091">
                <a:solidFill>
                  <a:schemeClr val="tx1">
                    <a:tint val="75000"/>
                  </a:schemeClr>
                </a:solidFill>
              </a:defRPr>
            </a:lvl1pPr>
            <a:lvl2pPr marL="207889" indent="0">
              <a:buNone/>
              <a:defRPr sz="909">
                <a:solidFill>
                  <a:schemeClr val="tx1">
                    <a:tint val="75000"/>
                  </a:schemeClr>
                </a:solidFill>
              </a:defRPr>
            </a:lvl2pPr>
            <a:lvl3pPr marL="415778" indent="0">
              <a:buNone/>
              <a:defRPr sz="818">
                <a:solidFill>
                  <a:schemeClr val="tx1">
                    <a:tint val="75000"/>
                  </a:schemeClr>
                </a:solidFill>
              </a:defRPr>
            </a:lvl3pPr>
            <a:lvl4pPr marL="623667" indent="0">
              <a:buNone/>
              <a:defRPr sz="728">
                <a:solidFill>
                  <a:schemeClr val="tx1">
                    <a:tint val="75000"/>
                  </a:schemeClr>
                </a:solidFill>
              </a:defRPr>
            </a:lvl4pPr>
            <a:lvl5pPr marL="831555" indent="0">
              <a:buNone/>
              <a:defRPr sz="728">
                <a:solidFill>
                  <a:schemeClr val="tx1">
                    <a:tint val="75000"/>
                  </a:schemeClr>
                </a:solidFill>
              </a:defRPr>
            </a:lvl5pPr>
            <a:lvl6pPr marL="1039444" indent="0">
              <a:buNone/>
              <a:defRPr sz="728">
                <a:solidFill>
                  <a:schemeClr val="tx1">
                    <a:tint val="75000"/>
                  </a:schemeClr>
                </a:solidFill>
              </a:defRPr>
            </a:lvl6pPr>
            <a:lvl7pPr marL="1247333" indent="0">
              <a:buNone/>
              <a:defRPr sz="728">
                <a:solidFill>
                  <a:schemeClr val="tx1">
                    <a:tint val="75000"/>
                  </a:schemeClr>
                </a:solidFill>
              </a:defRPr>
            </a:lvl7pPr>
            <a:lvl8pPr marL="1455222" indent="0">
              <a:buNone/>
              <a:defRPr sz="728">
                <a:solidFill>
                  <a:schemeClr val="tx1">
                    <a:tint val="75000"/>
                  </a:schemeClr>
                </a:solidFill>
              </a:defRPr>
            </a:lvl8pPr>
            <a:lvl9pPr marL="1663111" indent="0">
              <a:buNone/>
              <a:defRPr sz="7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792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1119" y="867172"/>
            <a:ext cx="2356009" cy="206688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06422" y="867172"/>
            <a:ext cx="2356009" cy="206688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967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841" y="173435"/>
            <a:ext cx="4781312" cy="629642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1841" y="798553"/>
            <a:ext cx="2345181" cy="391358"/>
          </a:xfrm>
        </p:spPr>
        <p:txBody>
          <a:bodyPr anchor="b"/>
          <a:lstStyle>
            <a:lvl1pPr marL="0" indent="0">
              <a:buNone/>
              <a:defRPr sz="1091" b="1"/>
            </a:lvl1pPr>
            <a:lvl2pPr marL="207889" indent="0">
              <a:buNone/>
              <a:defRPr sz="909" b="1"/>
            </a:lvl2pPr>
            <a:lvl3pPr marL="415778" indent="0">
              <a:buNone/>
              <a:defRPr sz="818" b="1"/>
            </a:lvl3pPr>
            <a:lvl4pPr marL="623667" indent="0">
              <a:buNone/>
              <a:defRPr sz="728" b="1"/>
            </a:lvl4pPr>
            <a:lvl5pPr marL="831555" indent="0">
              <a:buNone/>
              <a:defRPr sz="728" b="1"/>
            </a:lvl5pPr>
            <a:lvl6pPr marL="1039444" indent="0">
              <a:buNone/>
              <a:defRPr sz="728" b="1"/>
            </a:lvl6pPr>
            <a:lvl7pPr marL="1247333" indent="0">
              <a:buNone/>
              <a:defRPr sz="728" b="1"/>
            </a:lvl7pPr>
            <a:lvl8pPr marL="1455222" indent="0">
              <a:buNone/>
              <a:defRPr sz="728" b="1"/>
            </a:lvl8pPr>
            <a:lvl9pPr marL="1663111" indent="0">
              <a:buNone/>
              <a:defRPr sz="728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1841" y="1189911"/>
            <a:ext cx="2345181" cy="1750179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806422" y="798553"/>
            <a:ext cx="2356731" cy="391358"/>
          </a:xfrm>
        </p:spPr>
        <p:txBody>
          <a:bodyPr anchor="b"/>
          <a:lstStyle>
            <a:lvl1pPr marL="0" indent="0">
              <a:buNone/>
              <a:defRPr sz="1091" b="1"/>
            </a:lvl1pPr>
            <a:lvl2pPr marL="207889" indent="0">
              <a:buNone/>
              <a:defRPr sz="909" b="1"/>
            </a:lvl2pPr>
            <a:lvl3pPr marL="415778" indent="0">
              <a:buNone/>
              <a:defRPr sz="818" b="1"/>
            </a:lvl3pPr>
            <a:lvl4pPr marL="623667" indent="0">
              <a:buNone/>
              <a:defRPr sz="728" b="1"/>
            </a:lvl4pPr>
            <a:lvl5pPr marL="831555" indent="0">
              <a:buNone/>
              <a:defRPr sz="728" b="1"/>
            </a:lvl5pPr>
            <a:lvl6pPr marL="1039444" indent="0">
              <a:buNone/>
              <a:defRPr sz="728" b="1"/>
            </a:lvl6pPr>
            <a:lvl7pPr marL="1247333" indent="0">
              <a:buNone/>
              <a:defRPr sz="728" b="1"/>
            </a:lvl7pPr>
            <a:lvl8pPr marL="1455222" indent="0">
              <a:buNone/>
              <a:defRPr sz="728" b="1"/>
            </a:lvl8pPr>
            <a:lvl9pPr marL="1663111" indent="0">
              <a:buNone/>
              <a:defRPr sz="728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806422" y="1189911"/>
            <a:ext cx="2356731" cy="1750179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377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135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555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841" y="217170"/>
            <a:ext cx="1787939" cy="760095"/>
          </a:xfrm>
        </p:spPr>
        <p:txBody>
          <a:bodyPr anchor="b"/>
          <a:lstStyle>
            <a:lvl1pPr>
              <a:defRPr sz="1455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56731" y="469027"/>
            <a:ext cx="2806422" cy="2314972"/>
          </a:xfrm>
        </p:spPr>
        <p:txBody>
          <a:bodyPr/>
          <a:lstStyle>
            <a:lvl1pPr>
              <a:defRPr sz="1455"/>
            </a:lvl1pPr>
            <a:lvl2pPr>
              <a:defRPr sz="1273"/>
            </a:lvl2pPr>
            <a:lvl3pPr>
              <a:defRPr sz="1091"/>
            </a:lvl3pPr>
            <a:lvl4pPr>
              <a:defRPr sz="909"/>
            </a:lvl4pPr>
            <a:lvl5pPr>
              <a:defRPr sz="909"/>
            </a:lvl5pPr>
            <a:lvl6pPr>
              <a:defRPr sz="909"/>
            </a:lvl6pPr>
            <a:lvl7pPr>
              <a:defRPr sz="909"/>
            </a:lvl7pPr>
            <a:lvl8pPr>
              <a:defRPr sz="909"/>
            </a:lvl8pPr>
            <a:lvl9pPr>
              <a:defRPr sz="909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841" y="977265"/>
            <a:ext cx="1787939" cy="1810504"/>
          </a:xfrm>
        </p:spPr>
        <p:txBody>
          <a:bodyPr/>
          <a:lstStyle>
            <a:lvl1pPr marL="0" indent="0">
              <a:buNone/>
              <a:defRPr sz="728"/>
            </a:lvl1pPr>
            <a:lvl2pPr marL="207889" indent="0">
              <a:buNone/>
              <a:defRPr sz="637"/>
            </a:lvl2pPr>
            <a:lvl3pPr marL="415778" indent="0">
              <a:buNone/>
              <a:defRPr sz="546"/>
            </a:lvl3pPr>
            <a:lvl4pPr marL="623667" indent="0">
              <a:buNone/>
              <a:defRPr sz="455"/>
            </a:lvl4pPr>
            <a:lvl5pPr marL="831555" indent="0">
              <a:buNone/>
              <a:defRPr sz="455"/>
            </a:lvl5pPr>
            <a:lvl6pPr marL="1039444" indent="0">
              <a:buNone/>
              <a:defRPr sz="455"/>
            </a:lvl6pPr>
            <a:lvl7pPr marL="1247333" indent="0">
              <a:buNone/>
              <a:defRPr sz="455"/>
            </a:lvl7pPr>
            <a:lvl8pPr marL="1455222" indent="0">
              <a:buNone/>
              <a:defRPr sz="455"/>
            </a:lvl8pPr>
            <a:lvl9pPr marL="1663111" indent="0">
              <a:buNone/>
              <a:defRPr sz="455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042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841" y="217170"/>
            <a:ext cx="1787939" cy="760095"/>
          </a:xfrm>
        </p:spPr>
        <p:txBody>
          <a:bodyPr anchor="b"/>
          <a:lstStyle>
            <a:lvl1pPr>
              <a:defRPr sz="1455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356731" y="469027"/>
            <a:ext cx="2806422" cy="2314972"/>
          </a:xfrm>
        </p:spPr>
        <p:txBody>
          <a:bodyPr anchor="t"/>
          <a:lstStyle>
            <a:lvl1pPr marL="0" indent="0">
              <a:buNone/>
              <a:defRPr sz="1455"/>
            </a:lvl1pPr>
            <a:lvl2pPr marL="207889" indent="0">
              <a:buNone/>
              <a:defRPr sz="1273"/>
            </a:lvl2pPr>
            <a:lvl3pPr marL="415778" indent="0">
              <a:buNone/>
              <a:defRPr sz="1091"/>
            </a:lvl3pPr>
            <a:lvl4pPr marL="623667" indent="0">
              <a:buNone/>
              <a:defRPr sz="909"/>
            </a:lvl4pPr>
            <a:lvl5pPr marL="831555" indent="0">
              <a:buNone/>
              <a:defRPr sz="909"/>
            </a:lvl5pPr>
            <a:lvl6pPr marL="1039444" indent="0">
              <a:buNone/>
              <a:defRPr sz="909"/>
            </a:lvl6pPr>
            <a:lvl7pPr marL="1247333" indent="0">
              <a:buNone/>
              <a:defRPr sz="909"/>
            </a:lvl7pPr>
            <a:lvl8pPr marL="1455222" indent="0">
              <a:buNone/>
              <a:defRPr sz="909"/>
            </a:lvl8pPr>
            <a:lvl9pPr marL="1663111" indent="0">
              <a:buNone/>
              <a:defRPr sz="909"/>
            </a:lvl9pPr>
          </a:lstStyle>
          <a:p>
            <a:r>
              <a:rPr lang="da-DK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841" y="977265"/>
            <a:ext cx="1787939" cy="1810504"/>
          </a:xfrm>
        </p:spPr>
        <p:txBody>
          <a:bodyPr/>
          <a:lstStyle>
            <a:lvl1pPr marL="0" indent="0">
              <a:buNone/>
              <a:defRPr sz="728"/>
            </a:lvl1pPr>
            <a:lvl2pPr marL="207889" indent="0">
              <a:buNone/>
              <a:defRPr sz="637"/>
            </a:lvl2pPr>
            <a:lvl3pPr marL="415778" indent="0">
              <a:buNone/>
              <a:defRPr sz="546"/>
            </a:lvl3pPr>
            <a:lvl4pPr marL="623667" indent="0">
              <a:buNone/>
              <a:defRPr sz="455"/>
            </a:lvl4pPr>
            <a:lvl5pPr marL="831555" indent="0">
              <a:buNone/>
              <a:defRPr sz="455"/>
            </a:lvl5pPr>
            <a:lvl6pPr marL="1039444" indent="0">
              <a:buNone/>
              <a:defRPr sz="455"/>
            </a:lvl6pPr>
            <a:lvl7pPr marL="1247333" indent="0">
              <a:buNone/>
              <a:defRPr sz="455"/>
            </a:lvl7pPr>
            <a:lvl8pPr marL="1455222" indent="0">
              <a:buNone/>
              <a:defRPr sz="455"/>
            </a:lvl8pPr>
            <a:lvl9pPr marL="1663111" indent="0">
              <a:buNone/>
              <a:defRPr sz="455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719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1119" y="173435"/>
            <a:ext cx="4781312" cy="6296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1119" y="867172"/>
            <a:ext cx="4781312" cy="2066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1119" y="3019267"/>
            <a:ext cx="1247299" cy="1734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4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303872-C9C1-4D49-8920-F4460436D74B}" type="datetimeFigureOut">
              <a:rPr lang="en-US" smtClean="0"/>
              <a:t>9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36301" y="3019267"/>
            <a:ext cx="1870948" cy="1734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4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915132" y="3019267"/>
            <a:ext cx="1247299" cy="1734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4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82DDAC-A959-409C-ACC2-2D58D426A8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221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15778" rtl="0" eaLnBrk="1" latinLnBrk="0" hangingPunct="1">
        <a:lnSpc>
          <a:spcPct val="90000"/>
        </a:lnSpc>
        <a:spcBef>
          <a:spcPct val="0"/>
        </a:spcBef>
        <a:buNone/>
        <a:defRPr sz="20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3944" indent="-103944" algn="l" defTabSz="415778" rtl="0" eaLnBrk="1" latinLnBrk="0" hangingPunct="1">
        <a:lnSpc>
          <a:spcPct val="90000"/>
        </a:lnSpc>
        <a:spcBef>
          <a:spcPts val="455"/>
        </a:spcBef>
        <a:buFont typeface="Arial" panose="020B0604020202020204" pitchFamily="34" charset="0"/>
        <a:buChar char="•"/>
        <a:defRPr sz="1273" kern="1200">
          <a:solidFill>
            <a:schemeClr val="tx1"/>
          </a:solidFill>
          <a:latin typeface="+mn-lt"/>
          <a:ea typeface="+mn-ea"/>
          <a:cs typeface="+mn-cs"/>
        </a:defRPr>
      </a:lvl1pPr>
      <a:lvl2pPr marL="311833" indent="-103944" algn="l" defTabSz="415778" rtl="0" eaLnBrk="1" latinLnBrk="0" hangingPunct="1">
        <a:lnSpc>
          <a:spcPct val="90000"/>
        </a:lnSpc>
        <a:spcBef>
          <a:spcPts val="227"/>
        </a:spcBef>
        <a:buFont typeface="Arial" panose="020B0604020202020204" pitchFamily="34" charset="0"/>
        <a:buChar char="•"/>
        <a:defRPr sz="1091" kern="1200">
          <a:solidFill>
            <a:schemeClr val="tx1"/>
          </a:solidFill>
          <a:latin typeface="+mn-lt"/>
          <a:ea typeface="+mn-ea"/>
          <a:cs typeface="+mn-cs"/>
        </a:defRPr>
      </a:lvl2pPr>
      <a:lvl3pPr marL="519722" indent="-103944" algn="l" defTabSz="415778" rtl="0" eaLnBrk="1" latinLnBrk="0" hangingPunct="1">
        <a:lnSpc>
          <a:spcPct val="90000"/>
        </a:lnSpc>
        <a:spcBef>
          <a:spcPts val="227"/>
        </a:spcBef>
        <a:buFont typeface="Arial" panose="020B0604020202020204" pitchFamily="34" charset="0"/>
        <a:buChar char="•"/>
        <a:defRPr sz="909" kern="1200">
          <a:solidFill>
            <a:schemeClr val="tx1"/>
          </a:solidFill>
          <a:latin typeface="+mn-lt"/>
          <a:ea typeface="+mn-ea"/>
          <a:cs typeface="+mn-cs"/>
        </a:defRPr>
      </a:lvl3pPr>
      <a:lvl4pPr marL="727611" indent="-103944" algn="l" defTabSz="415778" rtl="0" eaLnBrk="1" latinLnBrk="0" hangingPunct="1">
        <a:lnSpc>
          <a:spcPct val="90000"/>
        </a:lnSpc>
        <a:spcBef>
          <a:spcPts val="227"/>
        </a:spcBef>
        <a:buFont typeface="Arial" panose="020B0604020202020204" pitchFamily="34" charset="0"/>
        <a:buChar char="•"/>
        <a:defRPr sz="818" kern="1200">
          <a:solidFill>
            <a:schemeClr val="tx1"/>
          </a:solidFill>
          <a:latin typeface="+mn-lt"/>
          <a:ea typeface="+mn-ea"/>
          <a:cs typeface="+mn-cs"/>
        </a:defRPr>
      </a:lvl4pPr>
      <a:lvl5pPr marL="935500" indent="-103944" algn="l" defTabSz="415778" rtl="0" eaLnBrk="1" latinLnBrk="0" hangingPunct="1">
        <a:lnSpc>
          <a:spcPct val="90000"/>
        </a:lnSpc>
        <a:spcBef>
          <a:spcPts val="227"/>
        </a:spcBef>
        <a:buFont typeface="Arial" panose="020B0604020202020204" pitchFamily="34" charset="0"/>
        <a:buChar char="•"/>
        <a:defRPr sz="818" kern="1200">
          <a:solidFill>
            <a:schemeClr val="tx1"/>
          </a:solidFill>
          <a:latin typeface="+mn-lt"/>
          <a:ea typeface="+mn-ea"/>
          <a:cs typeface="+mn-cs"/>
        </a:defRPr>
      </a:lvl5pPr>
      <a:lvl6pPr marL="1143389" indent="-103944" algn="l" defTabSz="415778" rtl="0" eaLnBrk="1" latinLnBrk="0" hangingPunct="1">
        <a:lnSpc>
          <a:spcPct val="90000"/>
        </a:lnSpc>
        <a:spcBef>
          <a:spcPts val="227"/>
        </a:spcBef>
        <a:buFont typeface="Arial" panose="020B0604020202020204" pitchFamily="34" charset="0"/>
        <a:buChar char="•"/>
        <a:defRPr sz="818" kern="1200">
          <a:solidFill>
            <a:schemeClr val="tx1"/>
          </a:solidFill>
          <a:latin typeface="+mn-lt"/>
          <a:ea typeface="+mn-ea"/>
          <a:cs typeface="+mn-cs"/>
        </a:defRPr>
      </a:lvl6pPr>
      <a:lvl7pPr marL="1351277" indent="-103944" algn="l" defTabSz="415778" rtl="0" eaLnBrk="1" latinLnBrk="0" hangingPunct="1">
        <a:lnSpc>
          <a:spcPct val="90000"/>
        </a:lnSpc>
        <a:spcBef>
          <a:spcPts val="227"/>
        </a:spcBef>
        <a:buFont typeface="Arial" panose="020B0604020202020204" pitchFamily="34" charset="0"/>
        <a:buChar char="•"/>
        <a:defRPr sz="818" kern="1200">
          <a:solidFill>
            <a:schemeClr val="tx1"/>
          </a:solidFill>
          <a:latin typeface="+mn-lt"/>
          <a:ea typeface="+mn-ea"/>
          <a:cs typeface="+mn-cs"/>
        </a:defRPr>
      </a:lvl7pPr>
      <a:lvl8pPr marL="1559166" indent="-103944" algn="l" defTabSz="415778" rtl="0" eaLnBrk="1" latinLnBrk="0" hangingPunct="1">
        <a:lnSpc>
          <a:spcPct val="90000"/>
        </a:lnSpc>
        <a:spcBef>
          <a:spcPts val="227"/>
        </a:spcBef>
        <a:buFont typeface="Arial" panose="020B0604020202020204" pitchFamily="34" charset="0"/>
        <a:buChar char="•"/>
        <a:defRPr sz="818" kern="1200">
          <a:solidFill>
            <a:schemeClr val="tx1"/>
          </a:solidFill>
          <a:latin typeface="+mn-lt"/>
          <a:ea typeface="+mn-ea"/>
          <a:cs typeface="+mn-cs"/>
        </a:defRPr>
      </a:lvl8pPr>
      <a:lvl9pPr marL="1767055" indent="-103944" algn="l" defTabSz="415778" rtl="0" eaLnBrk="1" latinLnBrk="0" hangingPunct="1">
        <a:lnSpc>
          <a:spcPct val="90000"/>
        </a:lnSpc>
        <a:spcBef>
          <a:spcPts val="227"/>
        </a:spcBef>
        <a:buFont typeface="Arial" panose="020B0604020202020204" pitchFamily="34" charset="0"/>
        <a:buChar char="•"/>
        <a:defRPr sz="81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5778" rtl="0" eaLnBrk="1" latinLnBrk="0" hangingPunct="1">
        <a:defRPr sz="818" kern="1200">
          <a:solidFill>
            <a:schemeClr val="tx1"/>
          </a:solidFill>
          <a:latin typeface="+mn-lt"/>
          <a:ea typeface="+mn-ea"/>
          <a:cs typeface="+mn-cs"/>
        </a:defRPr>
      </a:lvl1pPr>
      <a:lvl2pPr marL="207889" algn="l" defTabSz="415778" rtl="0" eaLnBrk="1" latinLnBrk="0" hangingPunct="1">
        <a:defRPr sz="818" kern="1200">
          <a:solidFill>
            <a:schemeClr val="tx1"/>
          </a:solidFill>
          <a:latin typeface="+mn-lt"/>
          <a:ea typeface="+mn-ea"/>
          <a:cs typeface="+mn-cs"/>
        </a:defRPr>
      </a:lvl2pPr>
      <a:lvl3pPr marL="415778" algn="l" defTabSz="415778" rtl="0" eaLnBrk="1" latinLnBrk="0" hangingPunct="1">
        <a:defRPr sz="818" kern="1200">
          <a:solidFill>
            <a:schemeClr val="tx1"/>
          </a:solidFill>
          <a:latin typeface="+mn-lt"/>
          <a:ea typeface="+mn-ea"/>
          <a:cs typeface="+mn-cs"/>
        </a:defRPr>
      </a:lvl3pPr>
      <a:lvl4pPr marL="623667" algn="l" defTabSz="415778" rtl="0" eaLnBrk="1" latinLnBrk="0" hangingPunct="1">
        <a:defRPr sz="818" kern="1200">
          <a:solidFill>
            <a:schemeClr val="tx1"/>
          </a:solidFill>
          <a:latin typeface="+mn-lt"/>
          <a:ea typeface="+mn-ea"/>
          <a:cs typeface="+mn-cs"/>
        </a:defRPr>
      </a:lvl4pPr>
      <a:lvl5pPr marL="831555" algn="l" defTabSz="415778" rtl="0" eaLnBrk="1" latinLnBrk="0" hangingPunct="1">
        <a:defRPr sz="818" kern="1200">
          <a:solidFill>
            <a:schemeClr val="tx1"/>
          </a:solidFill>
          <a:latin typeface="+mn-lt"/>
          <a:ea typeface="+mn-ea"/>
          <a:cs typeface="+mn-cs"/>
        </a:defRPr>
      </a:lvl5pPr>
      <a:lvl6pPr marL="1039444" algn="l" defTabSz="415778" rtl="0" eaLnBrk="1" latinLnBrk="0" hangingPunct="1">
        <a:defRPr sz="818" kern="1200">
          <a:solidFill>
            <a:schemeClr val="tx1"/>
          </a:solidFill>
          <a:latin typeface="+mn-lt"/>
          <a:ea typeface="+mn-ea"/>
          <a:cs typeface="+mn-cs"/>
        </a:defRPr>
      </a:lvl6pPr>
      <a:lvl7pPr marL="1247333" algn="l" defTabSz="415778" rtl="0" eaLnBrk="1" latinLnBrk="0" hangingPunct="1">
        <a:defRPr sz="818" kern="1200">
          <a:solidFill>
            <a:schemeClr val="tx1"/>
          </a:solidFill>
          <a:latin typeface="+mn-lt"/>
          <a:ea typeface="+mn-ea"/>
          <a:cs typeface="+mn-cs"/>
        </a:defRPr>
      </a:lvl7pPr>
      <a:lvl8pPr marL="1455222" algn="l" defTabSz="415778" rtl="0" eaLnBrk="1" latinLnBrk="0" hangingPunct="1">
        <a:defRPr sz="818" kern="1200">
          <a:solidFill>
            <a:schemeClr val="tx1"/>
          </a:solidFill>
          <a:latin typeface="+mn-lt"/>
          <a:ea typeface="+mn-ea"/>
          <a:cs typeface="+mn-cs"/>
        </a:defRPr>
      </a:lvl8pPr>
      <a:lvl9pPr marL="1663111" algn="l" defTabSz="415778" rtl="0" eaLnBrk="1" latinLnBrk="0" hangingPunct="1">
        <a:defRPr sz="81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E2ABA1DA-F15F-4269-98FD-C81031B9E9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3118135"/>
              </p:ext>
            </p:extLst>
          </p:nvPr>
        </p:nvGraphicFramePr>
        <p:xfrm>
          <a:off x="642747" y="663945"/>
          <a:ext cx="4258055" cy="19296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11648">
                  <a:extLst>
                    <a:ext uri="{9D8B030D-6E8A-4147-A177-3AD203B41FA5}">
                      <a16:colId xmlns:a16="http://schemas.microsoft.com/office/drawing/2014/main" val="3196977994"/>
                    </a:ext>
                  </a:extLst>
                </a:gridCol>
                <a:gridCol w="756287">
                  <a:extLst>
                    <a:ext uri="{9D8B030D-6E8A-4147-A177-3AD203B41FA5}">
                      <a16:colId xmlns:a16="http://schemas.microsoft.com/office/drawing/2014/main" val="4022409269"/>
                    </a:ext>
                  </a:extLst>
                </a:gridCol>
                <a:gridCol w="809004">
                  <a:extLst>
                    <a:ext uri="{9D8B030D-6E8A-4147-A177-3AD203B41FA5}">
                      <a16:colId xmlns:a16="http://schemas.microsoft.com/office/drawing/2014/main" val="2949764674"/>
                    </a:ext>
                  </a:extLst>
                </a:gridCol>
                <a:gridCol w="721791">
                  <a:extLst>
                    <a:ext uri="{9D8B030D-6E8A-4147-A177-3AD203B41FA5}">
                      <a16:colId xmlns:a16="http://schemas.microsoft.com/office/drawing/2014/main" val="1144467942"/>
                    </a:ext>
                  </a:extLst>
                </a:gridCol>
                <a:gridCol w="859325">
                  <a:extLst>
                    <a:ext uri="{9D8B030D-6E8A-4147-A177-3AD203B41FA5}">
                      <a16:colId xmlns:a16="http://schemas.microsoft.com/office/drawing/2014/main" val="1642546292"/>
                    </a:ext>
                  </a:extLst>
                </a:gridCol>
              </a:tblGrid>
              <a:tr h="19431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50" b="1" dirty="0"/>
                        <a:t>Patient ID</a:t>
                      </a:r>
                    </a:p>
                  </a:txBody>
                  <a:tcPr marL="68580" marR="68580" marT="34290" marB="3429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Baseline</a:t>
                      </a:r>
                    </a:p>
                  </a:txBody>
                  <a:tcPr marL="68580" marR="68580" marT="34290" marB="34290"/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EOT</a:t>
                      </a:r>
                    </a:p>
                  </a:txBody>
                  <a:tcPr marL="68580" marR="68580" marT="34290" marB="34290"/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8650198"/>
                  </a:ext>
                </a:extLst>
              </a:tr>
              <a:tr h="194310">
                <a:tc v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dirty="0"/>
                        <a:t>ArgLong2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dirty="0"/>
                        <a:t>PD-L1Long1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dirty="0"/>
                        <a:t>ArgLong2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dirty="0"/>
                        <a:t>PD-L1Long1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674749369"/>
                  </a:ext>
                </a:extLst>
              </a:tr>
              <a:tr h="246680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Pt#1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/A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N/A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*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*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99224859"/>
                  </a:ext>
                </a:extLst>
              </a:tr>
              <a:tr h="24668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Pt#2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s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s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*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*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6576846"/>
                  </a:ext>
                </a:extLst>
              </a:tr>
              <a:tr h="24668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Pt#3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/A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N/A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*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s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886095323"/>
                  </a:ext>
                </a:extLst>
              </a:tr>
              <a:tr h="24668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Pt#6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/A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N/A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*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*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66746199"/>
                  </a:ext>
                </a:extLst>
              </a:tr>
              <a:tr h="24668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Pt#8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/A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N/A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s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s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2386549295"/>
                  </a:ext>
                </a:extLst>
              </a:tr>
              <a:tr h="24668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Pt#9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*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ns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N/A</a:t>
                      </a:r>
                    </a:p>
                  </a:txBody>
                  <a:tcPr marL="68580" marR="68580" marT="34290" marB="3429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*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26046753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35810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68</Words>
  <Application>Microsoft Office PowerPoint</Application>
  <PresentationFormat>Brugerdefineret</PresentationFormat>
  <Paragraphs>37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æ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elina Martinenaite</dc:creator>
  <cp:lastModifiedBy>Mads Hald Andersen</cp:lastModifiedBy>
  <cp:revision>8</cp:revision>
  <cp:lastPrinted>2021-09-02T13:27:32Z</cp:lastPrinted>
  <dcterms:created xsi:type="dcterms:W3CDTF">2021-09-02T13:18:25Z</dcterms:created>
  <dcterms:modified xsi:type="dcterms:W3CDTF">2022-09-13T09:51:00Z</dcterms:modified>
</cp:coreProperties>
</file>